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1"/>
  </p:notesMasterIdLst>
  <p:sldIdLst>
    <p:sldId id="257" r:id="rId2"/>
    <p:sldId id="256" r:id="rId3"/>
    <p:sldId id="258" r:id="rId4"/>
    <p:sldId id="259" r:id="rId5"/>
    <p:sldId id="260" r:id="rId6"/>
    <p:sldId id="261" r:id="rId7"/>
    <p:sldId id="262" r:id="rId8"/>
    <p:sldId id="264" r:id="rId9"/>
    <p:sldId id="265" r:id="rId10"/>
  </p:sldIdLst>
  <p:sldSz cx="6858000" cy="990758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25"/>
    <p:restoredTop sz="94665"/>
  </p:normalViewPr>
  <p:slideViewPr>
    <p:cSldViewPr snapToGrid="0" snapToObjects="1">
      <p:cViewPr>
        <p:scale>
          <a:sx n="100" d="100"/>
          <a:sy n="100" d="100"/>
        </p:scale>
        <p:origin x="3104" y="-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notesMaster" Target="notesMasters/notesMaster1.xml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99062E-5996-A341-A213-54A6F1F1D286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53C412-D85C-214C-8EA2-8F9235224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6870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B7BEF-EAAA-D84B-9407-34FADD033DFD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4B62-BE74-9846-A62B-FA22E6B34D9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B7BEF-EAAA-D84B-9407-34FADD033DFD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4B62-BE74-9846-A62B-FA22E6B34D9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B7BEF-EAAA-D84B-9407-34FADD033DFD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4B62-BE74-9846-A62B-FA22E6B34D9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B7BEF-EAAA-D84B-9407-34FADD033DFD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4B62-BE74-9846-A62B-FA22E6B34D9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B7BEF-EAAA-D84B-9407-34FADD033DFD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4B62-BE74-9846-A62B-FA22E6B34D9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B7BEF-EAAA-D84B-9407-34FADD033DFD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4B62-BE74-9846-A62B-FA22E6B34D9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B7BEF-EAAA-D84B-9407-34FADD033DFD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4B62-BE74-9846-A62B-FA22E6B34D9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B7BEF-EAAA-D84B-9407-34FADD033DFD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4B62-BE74-9846-A62B-FA22E6B34D9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B7BEF-EAAA-D84B-9407-34FADD033DFD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4B62-BE74-9846-A62B-FA22E6B34D9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B7BEF-EAAA-D84B-9407-34FADD033DFD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4B62-BE74-9846-A62B-FA22E6B34D9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B7BEF-EAAA-D84B-9407-34FADD033DFD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4B62-BE74-9846-A62B-FA22E6B34D9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B7BEF-EAAA-D84B-9407-34FADD033DFD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494B62-BE74-9846-A62B-FA22E6B34D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143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0640" y="685036"/>
            <a:ext cx="3086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(A) </a:t>
            </a:r>
            <a:r>
              <a:rPr lang="en-US" sz="1400" i="1" dirty="0" err="1" smtClean="0">
                <a:latin typeface="Arial" charset="0"/>
                <a:ea typeface="Arial" charset="0"/>
                <a:cs typeface="Arial" charset="0"/>
              </a:rPr>
              <a:t>S.italica</a:t>
            </a:r>
            <a:endParaRPr lang="en-US" sz="12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30639" y="1910286"/>
            <a:ext cx="960699" cy="3240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13"/>
          <a:stretch/>
        </p:blipFill>
        <p:spPr>
          <a:xfrm>
            <a:off x="413558" y="1199398"/>
            <a:ext cx="5806362" cy="57453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58019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2986"/>
            <a:ext cx="6806481" cy="652032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0640" y="685036"/>
            <a:ext cx="3086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(B) </a:t>
            </a:r>
            <a:r>
              <a:rPr lang="en-US" sz="1400" i="1" dirty="0" err="1" smtClean="0">
                <a:latin typeface="Arial" charset="0"/>
                <a:ea typeface="Arial" charset="0"/>
                <a:cs typeface="Arial" charset="0"/>
              </a:rPr>
              <a:t>S.bicolor</a:t>
            </a:r>
            <a:endParaRPr lang="en-US" sz="12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0" y="2129742"/>
            <a:ext cx="960699" cy="3240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280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30640" y="685036"/>
            <a:ext cx="3086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(C) </a:t>
            </a:r>
            <a:r>
              <a:rPr lang="en-US" sz="1400" i="1" dirty="0" err="1" smtClean="0">
                <a:latin typeface="Arial" charset="0"/>
                <a:ea typeface="Arial" charset="0"/>
                <a:cs typeface="Arial" charset="0"/>
              </a:rPr>
              <a:t>Z.mays</a:t>
            </a:r>
            <a:endParaRPr lang="en-US" sz="1200" i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8" name="Content Placeholder 7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226" y="1108935"/>
            <a:ext cx="5915025" cy="6086375"/>
          </a:xfrm>
        </p:spPr>
      </p:pic>
      <p:sp>
        <p:nvSpPr>
          <p:cNvPr id="9" name="Rectangle 8"/>
          <p:cNvSpPr/>
          <p:nvPr/>
        </p:nvSpPr>
        <p:spPr>
          <a:xfrm>
            <a:off x="359226" y="1739598"/>
            <a:ext cx="960699" cy="3240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831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48"/>
          <a:stretch/>
        </p:blipFill>
        <p:spPr>
          <a:xfrm>
            <a:off x="230639" y="792480"/>
            <a:ext cx="7138726" cy="6461565"/>
          </a:xfrm>
        </p:spPr>
      </p:pic>
      <p:sp>
        <p:nvSpPr>
          <p:cNvPr id="8" name="TextBox 7"/>
          <p:cNvSpPr txBox="1"/>
          <p:nvPr/>
        </p:nvSpPr>
        <p:spPr>
          <a:xfrm>
            <a:off x="230640" y="685036"/>
            <a:ext cx="3086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(D) </a:t>
            </a:r>
            <a:r>
              <a:rPr lang="en-US" sz="1400" i="1" dirty="0" err="1" smtClean="0">
                <a:latin typeface="Arial" charset="0"/>
                <a:ea typeface="Arial" charset="0"/>
                <a:cs typeface="Arial" charset="0"/>
              </a:rPr>
              <a:t>O.sativa</a:t>
            </a:r>
            <a:endParaRPr lang="en-US" sz="1400" i="1" dirty="0" smtClean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59375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Content Placeholder 7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78"/>
          <a:stretch/>
        </p:blipFill>
        <p:spPr>
          <a:xfrm>
            <a:off x="230639" y="152318"/>
            <a:ext cx="7876032" cy="7196040"/>
          </a:xfrm>
        </p:spPr>
      </p:pic>
      <p:sp>
        <p:nvSpPr>
          <p:cNvPr id="6" name="TextBox 5"/>
          <p:cNvSpPr txBox="1"/>
          <p:nvPr/>
        </p:nvSpPr>
        <p:spPr>
          <a:xfrm>
            <a:off x="230640" y="685036"/>
            <a:ext cx="3086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(E) </a:t>
            </a:r>
            <a:r>
              <a:rPr lang="en-US" sz="1400" i="1" dirty="0" err="1" smtClean="0">
                <a:latin typeface="Arial" charset="0"/>
                <a:ea typeface="Arial" charset="0"/>
                <a:cs typeface="Arial" charset="0"/>
              </a:rPr>
              <a:t>B.distachyon</a:t>
            </a:r>
            <a:endParaRPr lang="en-US" sz="1200" i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17016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30640" y="685036"/>
            <a:ext cx="3086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(F) </a:t>
            </a:r>
            <a:r>
              <a:rPr lang="en-US" sz="1400" i="1" dirty="0" err="1" smtClean="0">
                <a:latin typeface="Arial" charset="0"/>
                <a:ea typeface="Arial" charset="0"/>
                <a:cs typeface="Arial" charset="0"/>
              </a:rPr>
              <a:t>H.vulgare</a:t>
            </a:r>
            <a:endParaRPr lang="en-US" sz="12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30638" y="2731008"/>
            <a:ext cx="95198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74"/>
          <a:stretch/>
        </p:blipFill>
        <p:spPr>
          <a:xfrm>
            <a:off x="254000" y="1117599"/>
            <a:ext cx="6184900" cy="64673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95452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0640" y="685036"/>
            <a:ext cx="3086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(G) </a:t>
            </a:r>
            <a:r>
              <a:rPr lang="en-US" sz="1400" i="1" dirty="0" err="1" smtClean="0">
                <a:latin typeface="Arial" charset="0"/>
                <a:ea typeface="Arial" charset="0"/>
                <a:cs typeface="Arial" charset="0"/>
              </a:rPr>
              <a:t>A.tauschii</a:t>
            </a:r>
            <a:endParaRPr lang="en-US" sz="1200" i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226" y="1684892"/>
            <a:ext cx="5915025" cy="5435618"/>
          </a:xfrm>
        </p:spPr>
      </p:pic>
      <p:sp>
        <p:nvSpPr>
          <p:cNvPr id="7" name="TextBox 6"/>
          <p:cNvSpPr txBox="1"/>
          <p:nvPr/>
        </p:nvSpPr>
        <p:spPr>
          <a:xfrm>
            <a:off x="256552" y="2523744"/>
            <a:ext cx="109676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80694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0640" y="685036"/>
            <a:ext cx="3086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(H) </a:t>
            </a:r>
            <a:r>
              <a:rPr lang="en-US" sz="1400" i="1" dirty="0" err="1" smtClean="0">
                <a:latin typeface="Arial" charset="0"/>
                <a:ea typeface="Arial" charset="0"/>
                <a:cs typeface="Arial" charset="0"/>
              </a:rPr>
              <a:t>T.aestivum</a:t>
            </a:r>
            <a:endParaRPr lang="en-US" sz="1200" i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986806" y="1140418"/>
            <a:ext cx="7667439" cy="6432538"/>
          </a:xfrm>
        </p:spPr>
      </p:pic>
      <p:sp>
        <p:nvSpPr>
          <p:cNvPr id="7" name="TextBox 6"/>
          <p:cNvSpPr txBox="1"/>
          <p:nvPr/>
        </p:nvSpPr>
        <p:spPr>
          <a:xfrm>
            <a:off x="-1219200" y="1438656"/>
            <a:ext cx="22311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11813045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30640" y="719760"/>
            <a:ext cx="3086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(I) </a:t>
            </a:r>
            <a:r>
              <a:rPr lang="en-US" sz="1400" i="1" dirty="0" err="1" smtClean="0">
                <a:latin typeface="Arial" charset="0"/>
                <a:ea typeface="Arial" charset="0"/>
                <a:cs typeface="Arial" charset="0"/>
              </a:rPr>
              <a:t>T.urartu</a:t>
            </a:r>
            <a:endParaRPr lang="en-US" sz="1200" i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8" name="Content Placeholder 7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87" r="20581"/>
          <a:stretch/>
        </p:blipFill>
        <p:spPr>
          <a:xfrm>
            <a:off x="752354" y="1027537"/>
            <a:ext cx="5752618" cy="6560053"/>
          </a:xfrm>
        </p:spPr>
      </p:pic>
      <p:sp>
        <p:nvSpPr>
          <p:cNvPr id="9" name="TextBox 8"/>
          <p:cNvSpPr txBox="1"/>
          <p:nvPr/>
        </p:nvSpPr>
        <p:spPr>
          <a:xfrm>
            <a:off x="658368" y="1560576"/>
            <a:ext cx="34137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836536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1</TotalTime>
  <Words>36</Words>
  <Application>Microsoft Macintosh PowerPoint</Application>
  <PresentationFormat>Custom</PresentationFormat>
  <Paragraphs>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Calibri</vt:lpstr>
      <vt:lpstr>Calibri Light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Paul Bailey (EI)</cp:lastModifiedBy>
  <cp:revision>10</cp:revision>
  <cp:lastPrinted>2017-01-12T12:06:35Z</cp:lastPrinted>
  <dcterms:created xsi:type="dcterms:W3CDTF">2017-01-04T14:20:30Z</dcterms:created>
  <dcterms:modified xsi:type="dcterms:W3CDTF">2017-12-20T14:20:56Z</dcterms:modified>
</cp:coreProperties>
</file>